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iRW4GMYJ6wnJebUjUCH/yjYeUaw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B181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/>
    <p:restoredTop sz="96918"/>
  </p:normalViewPr>
  <p:slideViewPr>
    <p:cSldViewPr snapToGrid="0" snapToObjects="1">
      <p:cViewPr>
        <p:scale>
          <a:sx n="400" d="100"/>
          <a:sy n="400" d="100"/>
        </p:scale>
        <p:origin x="-448" y="-87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12" Type="http://customschemas.google.com/relationships/presentationmetadata" Target="meta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5" Type="http://schemas.openxmlformats.org/officeDocument/2006/relationships/theme" Target="theme/theme1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9" name="Google Shape;379;g1093fa729ab_1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80" name="Google Shape;380;g1093fa729ab_1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7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7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9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9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4" name="Google Shape;24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4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75305E3-4064-C14A-AC2E-CCDF95CBC48B}"/>
              </a:ext>
            </a:extLst>
          </p:cNvPr>
          <p:cNvGrpSpPr/>
          <p:nvPr/>
        </p:nvGrpSpPr>
        <p:grpSpPr>
          <a:xfrm>
            <a:off x="1486240" y="2271736"/>
            <a:ext cx="3704457" cy="1885939"/>
            <a:chOff x="1486240" y="2271736"/>
            <a:chExt cx="3704457" cy="1885939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FE77AE5F-E937-7245-B908-C790F28E4762}"/>
                </a:ext>
              </a:extLst>
            </p:cNvPr>
            <p:cNvGrpSpPr/>
            <p:nvPr/>
          </p:nvGrpSpPr>
          <p:grpSpPr>
            <a:xfrm>
              <a:off x="1486240" y="2271736"/>
              <a:ext cx="1548144" cy="1876914"/>
              <a:chOff x="1410040" y="2114568"/>
              <a:chExt cx="1548144" cy="1876914"/>
            </a:xfrm>
          </p:grpSpPr>
          <p:pic>
            <p:nvPicPr>
              <p:cNvPr id="383" name="Google Shape;383;g1093fa729ab_1_0"/>
              <p:cNvPicPr preferRelativeResize="0"/>
              <p:nvPr/>
            </p:nvPicPr>
            <p:blipFill rotWithShape="1">
              <a:blip r:embed="rId3">
                <a:alphaModFix/>
              </a:blip>
              <a:srcRect l="13916" t="18549" r="25754" b="17616"/>
              <a:stretch/>
            </p:blipFill>
            <p:spPr>
              <a:xfrm rot="5400000">
                <a:off x="1283024" y="2352664"/>
                <a:ext cx="1828800" cy="1448836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84" name="Google Shape;384;g1093fa729ab_1_0"/>
              <p:cNvSpPr txBox="1"/>
              <p:nvPr/>
            </p:nvSpPr>
            <p:spPr>
              <a:xfrm>
                <a:off x="2685184" y="2114568"/>
                <a:ext cx="273000" cy="2769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00"/>
                  <a:buFont typeface="Arial"/>
                  <a:buNone/>
                </a:pPr>
                <a:r>
                  <a:rPr lang="fr-FR" sz="1200" i="0" u="none" strike="noStrike" cap="none" noProof="1">
                    <a:solidFill>
                      <a:schemeClr val="tx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a</a:t>
                </a:r>
                <a:endParaRPr lang="fr-FR" sz="1000" i="0" u="none" strike="noStrike" cap="none" noProof="1">
                  <a:solidFill>
                    <a:schemeClr val="tx1"/>
                  </a:solidFill>
                  <a:latin typeface="+mn-lt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89" name="Google Shape;389;g1093fa729ab_1_0"/>
              <p:cNvSpPr/>
              <p:nvPr/>
            </p:nvSpPr>
            <p:spPr>
              <a:xfrm>
                <a:off x="1410040" y="3304331"/>
                <a:ext cx="369482" cy="26638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fr-FR" sz="1000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pb</a:t>
                </a:r>
                <a:endParaRPr lang="fr-FR" sz="1000" i="0" u="none" strike="noStrike" cap="none" noProof="1">
                  <a:solidFill>
                    <a:schemeClr val="dk1"/>
                  </a:solidFill>
                  <a:latin typeface="+mn-lt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90" name="Google Shape;390;g1093fa729ab_1_0"/>
              <p:cNvSpPr txBox="1"/>
              <p:nvPr/>
            </p:nvSpPr>
            <p:spPr>
              <a:xfrm>
                <a:off x="2188401" y="3238117"/>
                <a:ext cx="549974" cy="3165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fr-FR" sz="1000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e</a:t>
                </a:r>
                <a:r>
                  <a:rPr lang="fr-FR" sz="1000" i="0" u="none" strike="noStrike" cap="none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mr</a:t>
                </a:r>
              </a:p>
            </p:txBody>
          </p:sp>
          <p:sp>
            <p:nvSpPr>
              <p:cNvPr id="391" name="Google Shape;391;g1093fa729ab_1_0"/>
              <p:cNvSpPr/>
              <p:nvPr/>
            </p:nvSpPr>
            <p:spPr>
              <a:xfrm>
                <a:off x="1747334" y="2149995"/>
                <a:ext cx="484872" cy="27241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fr-FR" sz="1000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s</a:t>
                </a:r>
                <a:r>
                  <a:rPr lang="fr-FR" sz="1000" i="0" u="none" strike="noStrike" cap="none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cpr</a:t>
                </a:r>
              </a:p>
            </p:txBody>
          </p:sp>
          <p:sp>
            <p:nvSpPr>
              <p:cNvPr id="392" name="Google Shape;392;g1093fa729ab_1_0"/>
              <p:cNvSpPr/>
              <p:nvPr/>
            </p:nvSpPr>
            <p:spPr>
              <a:xfrm>
                <a:off x="2032947" y="2823856"/>
                <a:ext cx="436245" cy="27241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fr-FR" sz="1000" i="0" u="none" strike="noStrike" cap="none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vas</a:t>
                </a:r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0FA58002-A0B5-BE4C-863A-71981CE18C4A}"/>
                </a:ext>
              </a:extLst>
            </p:cNvPr>
            <p:cNvGrpSpPr/>
            <p:nvPr/>
          </p:nvGrpSpPr>
          <p:grpSpPr>
            <a:xfrm>
              <a:off x="3201239" y="2271739"/>
              <a:ext cx="1989458" cy="1885936"/>
              <a:chOff x="3125039" y="2114571"/>
              <a:chExt cx="1989458" cy="1885936"/>
            </a:xfrm>
          </p:grpSpPr>
          <p:pic>
            <p:nvPicPr>
              <p:cNvPr id="386" name="Google Shape;386;g1093fa729ab_1_0"/>
              <p:cNvPicPr preferRelativeResize="0"/>
              <p:nvPr/>
            </p:nvPicPr>
            <p:blipFill rotWithShape="1">
              <a:blip r:embed="rId4">
                <a:alphaModFix/>
              </a:blip>
              <a:srcRect l="1648" t="7102" r="33950" b="4658"/>
              <a:stretch/>
            </p:blipFill>
            <p:spPr>
              <a:xfrm rot="16200000" flipH="1">
                <a:off x="3176789" y="2110932"/>
                <a:ext cx="1837825" cy="1941326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87" name="Google Shape;387;g1093fa729ab_1_0"/>
              <p:cNvSpPr txBox="1"/>
              <p:nvPr/>
            </p:nvSpPr>
            <p:spPr>
              <a:xfrm>
                <a:off x="4841497" y="2114571"/>
                <a:ext cx="273000" cy="2769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00"/>
                  <a:buFont typeface="Arial"/>
                  <a:buNone/>
                </a:pPr>
                <a:r>
                  <a:rPr lang="fr-FR" sz="1200" i="0" u="none" strike="noStrike" cap="none" noProof="1">
                    <a:solidFill>
                      <a:schemeClr val="tx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b</a:t>
                </a:r>
                <a:endParaRPr lang="fr-FR" sz="1000" i="0" u="none" strike="noStrike" cap="none" noProof="1">
                  <a:solidFill>
                    <a:schemeClr val="tx1"/>
                  </a:solidFill>
                  <a:latin typeface="+mn-lt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93" name="Google Shape;393;g1093fa729ab_1_0"/>
              <p:cNvSpPr/>
              <p:nvPr/>
            </p:nvSpPr>
            <p:spPr>
              <a:xfrm>
                <a:off x="4245572" y="3080621"/>
                <a:ext cx="436245" cy="27241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fr-FR" sz="1000" i="0" u="none" strike="noStrike" cap="none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vas</a:t>
                </a:r>
              </a:p>
            </p:txBody>
          </p:sp>
          <p:sp>
            <p:nvSpPr>
              <p:cNvPr id="394" name="Google Shape;394;g1093fa729ab_1_0"/>
              <p:cNvSpPr/>
              <p:nvPr/>
            </p:nvSpPr>
            <p:spPr>
              <a:xfrm>
                <a:off x="3908092" y="3350790"/>
                <a:ext cx="436245" cy="27241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fr-FR" sz="1000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scpr</a:t>
                </a:r>
                <a:endParaRPr lang="fr-FR" sz="1000" i="0" u="none" strike="noStrike" cap="none" noProof="1">
                  <a:solidFill>
                    <a:schemeClr val="dk1"/>
                  </a:solidFill>
                  <a:latin typeface="+mn-lt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95" name="Google Shape;395;g1093fa729ab_1_0"/>
              <p:cNvSpPr/>
              <p:nvPr/>
            </p:nvSpPr>
            <p:spPr>
              <a:xfrm>
                <a:off x="3493437" y="2370450"/>
                <a:ext cx="414655" cy="27241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fr-FR" sz="1000" i="0" u="none" strike="noStrike" cap="none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sr</a:t>
                </a:r>
              </a:p>
            </p:txBody>
          </p:sp>
          <p:sp>
            <p:nvSpPr>
              <p:cNvPr id="396" name="Google Shape;396;g1093fa729ab_1_0"/>
              <p:cNvSpPr/>
              <p:nvPr/>
            </p:nvSpPr>
            <p:spPr>
              <a:xfrm>
                <a:off x="3168938" y="3565370"/>
                <a:ext cx="369482" cy="26638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fr-FR" sz="1000" i="0" u="none" strike="noStrike" cap="none" noProof="1">
                    <a:solidFill>
                      <a:schemeClr val="dk1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pb</a:t>
                </a:r>
              </a:p>
            </p:txBody>
          </p:sp>
        </p:grpSp>
      </p:grpSp>
      <p:sp>
        <p:nvSpPr>
          <p:cNvPr id="22" name="Google Shape;388;g1093fa729ab_1_0">
            <a:extLst>
              <a:ext uri="{FF2B5EF4-FFF2-40B4-BE49-F238E27FC236}">
                <a16:creationId xmlns:a16="http://schemas.microsoft.com/office/drawing/2014/main" id="{6D6BFECB-599B-5441-BAA0-27F7A2682B7E}"/>
              </a:ext>
            </a:extLst>
          </p:cNvPr>
          <p:cNvSpPr/>
          <p:nvPr/>
        </p:nvSpPr>
        <p:spPr>
          <a:xfrm>
            <a:off x="549000" y="4548744"/>
            <a:ext cx="5760000" cy="1118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 algn="just"/>
            <a:r>
              <a:rPr lang="en-GB" sz="1100" b="1"/>
              <a:t>Supplementary Figure S3</a:t>
            </a:r>
            <a:r>
              <a:rPr lang="en-GB" sz="1100" b="1" dirty="0"/>
              <a:t>.</a:t>
            </a:r>
            <a:r>
              <a:rPr lang="en-GB" sz="1100"/>
              <a:t> </a:t>
            </a:r>
            <a:r>
              <a:rPr lang="en-GB" sz="1100" dirty="0"/>
              <a:t>Expression of </a:t>
            </a:r>
            <a:r>
              <a:rPr lang="en-GB" sz="1100" i="1" dirty="0" err="1"/>
              <a:t>BdSamDc</a:t>
            </a:r>
            <a:r>
              <a:rPr lang="en-GB" sz="1100" dirty="0"/>
              <a:t> in immature zygotic embryos sections. Panels show RNA </a:t>
            </a:r>
            <a:r>
              <a:rPr lang="en-GB" sz="1100" i="1" dirty="0"/>
              <a:t>in situ</a:t>
            </a:r>
            <a:r>
              <a:rPr lang="en-GB" sz="1100" dirty="0"/>
              <a:t> hybridization of an antisense RNA probe in sections of d3</a:t>
            </a:r>
            <a:r>
              <a:rPr lang="en-GB" sz="1100" baseline="-25000" dirty="0"/>
              <a:t>CIM </a:t>
            </a:r>
            <a:r>
              <a:rPr lang="en-GB" sz="1100" dirty="0" err="1"/>
              <a:t>izEmb</a:t>
            </a:r>
            <a:r>
              <a:rPr lang="en-GB" sz="1100" dirty="0"/>
              <a:t> explants, in the sagittal (</a:t>
            </a:r>
            <a:r>
              <a:rPr lang="en-GB" sz="1100" b="1" dirty="0"/>
              <a:t>a</a:t>
            </a:r>
            <a:r>
              <a:rPr lang="en-GB" sz="1100" dirty="0"/>
              <a:t>) or frontal (</a:t>
            </a:r>
            <a:r>
              <a:rPr lang="en-GB" sz="1100" b="1" dirty="0"/>
              <a:t>b</a:t>
            </a:r>
            <a:r>
              <a:rPr lang="en-GB" sz="1100" dirty="0"/>
              <a:t>) orientation. The gene is transcribed in cells of lateral scutellum protrusion (</a:t>
            </a:r>
            <a:r>
              <a:rPr lang="en-GB" sz="1100" dirty="0" err="1"/>
              <a:t>scpr</a:t>
            </a:r>
            <a:r>
              <a:rPr lang="en-GB" sz="1100" dirty="0"/>
              <a:t>), in cells next to the proliferative bulge (pb) or to the proliferative embryonic root (</a:t>
            </a:r>
            <a:r>
              <a:rPr lang="en-GB" sz="1100" dirty="0" err="1"/>
              <a:t>emr</a:t>
            </a:r>
            <a:r>
              <a:rPr lang="en-GB" sz="1100" dirty="0"/>
              <a:t>) tissues, but at lower or undetectable levels in the inner scutellum tissues (</a:t>
            </a:r>
            <a:r>
              <a:rPr lang="en-GB" sz="1100" dirty="0" err="1"/>
              <a:t>sc</a:t>
            </a:r>
            <a:r>
              <a:rPr lang="en-GB" sz="1100" dirty="0"/>
              <a:t>) or the seminal root (</a:t>
            </a:r>
            <a:r>
              <a:rPr lang="en-GB" sz="1100" dirty="0" err="1"/>
              <a:t>sr</a:t>
            </a:r>
            <a:r>
              <a:rPr lang="en-GB" sz="1100" dirty="0"/>
              <a:t>). (</a:t>
            </a:r>
            <a:r>
              <a:rPr lang="en-GB" sz="1100" i="1" dirty="0"/>
              <a:t>bar</a:t>
            </a:r>
            <a:r>
              <a:rPr lang="en-GB" sz="1100" dirty="0"/>
              <a:t> 200 </a:t>
            </a:r>
            <a:r>
              <a:rPr lang="el-GR" sz="1100" dirty="0"/>
              <a:t>μ</a:t>
            </a:r>
            <a:r>
              <a:rPr lang="en-GB" sz="1100" dirty="0"/>
              <a:t>m)</a:t>
            </a:r>
            <a:endParaRPr lang="en-US" sz="1100" b="0" i="0" u="none" strike="noStrike" cap="none" dirty="0">
              <a:solidFill>
                <a:schemeClr val="tx1"/>
              </a:solidFill>
              <a:latin typeface="+mn-lt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18</TotalTime>
  <Words>115</Words>
  <Application>Microsoft Macintosh PowerPoint</Application>
  <PresentationFormat>A4 Paper (210x297 mm)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Oumaya Bouchabke</dc:creator>
  <cp:keywords/>
  <dc:description/>
  <cp:lastModifiedBy>Pierre</cp:lastModifiedBy>
  <cp:revision>63</cp:revision>
  <dcterms:modified xsi:type="dcterms:W3CDTF">2022-04-06T16:16:52Z</dcterms:modified>
  <cp:category/>
</cp:coreProperties>
</file>